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989"/>
    <a:srgbClr val="8BD9F1"/>
    <a:srgbClr val="1690B6"/>
    <a:srgbClr val="C80896"/>
    <a:srgbClr val="22B8E5"/>
    <a:srgbClr val="C00000"/>
    <a:srgbClr val="512507"/>
    <a:srgbClr val="B1510F"/>
    <a:srgbClr val="1693BA"/>
    <a:srgbClr val="1277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855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F280A7-E345-43F3-A0C4-F95BB4A2EABA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7BF7A9-8B33-43CD-A4C8-A09B799DBBE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12292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A3C85E-F786-5D26-A0B7-D5A477499C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FB94669-C404-B597-114E-C1DB8D9A5A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1AAC03-73A4-1FF1-8259-149E7745A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DC0A4A-CAD6-BA49-C564-1B3A930D41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F235ED-2671-6D98-D0DD-44780BAC5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329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BC1688-1995-1357-8A17-F9D936CB0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FC3D897-4F77-AC91-43AD-82609940E1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7CF932-98E6-1566-0B59-3A7CCE99F0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DA0198-26B5-03AC-2364-81809BEFFB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C4E603-A33A-3E98-6262-3A61087E3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7854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0F80EE6-CBE3-9B63-D2A5-0AEDC808AA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2A2F74C-5F99-F00A-9ADF-4D15526F06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2418C7-248B-EE55-4478-A9E99F530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300543-EB9E-BBF4-1267-B278D775C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9E3F31-A06A-FE72-1248-F409BB250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8313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664BA-38B7-3F29-B14C-43D611F014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366A361-CA0D-3E91-6BBE-01DFCA1DA7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E9C680-705D-EF43-9007-355EBD664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84FB60-8E6D-BDA8-1E3D-28DDCF7A9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6FD27C4-EE4E-B233-6FBA-1A5D8A1E5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7302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F60F7E-39E3-8FFD-50A5-7B776C406F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C031AF6-9C71-E4F2-3B54-C5D0506DFA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2C1BC6-4CC1-CD26-C37A-D104D9766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A8C896-0DA5-9723-BFF7-F178BA9DE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DE6E30-461C-9D85-3034-EA499AFAC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4812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BDA791-B48E-E0AA-9ED1-627E909020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AF659F3-DC60-DA78-180C-B922C25949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D488CEE-0894-462B-8A75-2BAB33BF2B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98B4BE-88D6-7B6F-CE83-BF03A4DD8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7FF6B67-95CA-25CA-27E0-FA4761E41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1FC0DF8-5CAB-98EF-D989-39EEF0713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7032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1EA8EA-F3F3-DCFD-AFAB-3740DB9B37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1FDC775-8F88-5221-E619-968BC31EA8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3584DCC-D285-3E6D-EFDC-D1A540FC78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170DB36-C5F9-BB19-E827-7C8F831A95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6F29B1E-2E8E-475C-4C13-8BC9A934A9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CCB593F-C69D-BA6F-FB97-3BC5D415C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697F7CB-1333-EFB3-C22D-D307B5DE7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098E2BE-DE4A-D6FC-530B-760631190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9994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8D7470-BFB2-07F1-B4A3-BE6D5CD88B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87EAE51-F470-A50A-035B-ACF3B3786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2B1AAC0-B0D5-E34B-7D0E-5FCDB0403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E4985BC-44B6-DC29-C275-DEE624767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9382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3AE38C9-4559-6B26-91F2-0DC728FDD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C2D8728-F0A2-C1C5-95B9-117C28363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D5F5152-16F7-F625-7E81-11778632B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7390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3666B7-176A-DEAD-6484-6E8585691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41CEEF6-384F-C4FA-DEA8-7DDE65200D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927C8E5-00B9-9A41-843F-AE9AEA1E21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E9404E-43C2-50C9-F72A-F3CB66B3F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28950D4-9B2B-FB2A-E4F9-394C64EBA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16AD912-7FD4-B780-E424-6D2948AF9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9584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EE015B-C0B6-D6B7-55F4-ED4E6AA43E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3D94DF1-C9CD-09C7-3CDA-DF9ACCBA9C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4ADB46-2644-26F4-7824-33D93F2878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747ADBC-B5F2-B2FC-C670-C5DD9A7E4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0495617-B52E-6003-6E29-DC4FBA6D5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490B06-0E8C-74A1-E005-AABA35F06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4129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6D67A8F-649C-5F38-D33C-A31DA325F6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E972712-B036-C37F-A2C4-361564D3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97E7C2-A31A-9A9B-03DE-FE7113EC4F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874C7-95F1-4A54-BD03-83B4A7E7B957}" type="datetimeFigureOut">
              <a:rPr lang="zh-CN" altLang="en-US" smtClean="0"/>
              <a:t>2024/6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7FEAF5-64BA-5132-7E82-FD67541DB4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5C20C1-5C03-44A7-B974-EC9C267D1A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D55DBF-522D-4050-8F93-9FD75CF2A5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0326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8A8892E4-18E5-AEF5-D192-57166AFC37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9212865"/>
              </p:ext>
            </p:extLst>
          </p:nvPr>
        </p:nvGraphicFramePr>
        <p:xfrm>
          <a:off x="1512032" y="590514"/>
          <a:ext cx="3893906" cy="48509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6" name="Prism 8" r:id="rId3" imgW="2538597" imgH="3162654" progId="Prism8.Document">
                  <p:embed/>
                </p:oleObj>
              </mc:Choice>
              <mc:Fallback>
                <p:oleObj name="Prism 8" r:id="rId3" imgW="2538597" imgH="316265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12032" y="590514"/>
                        <a:ext cx="3893906" cy="48509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11DDF799-D1B7-64D8-0ECA-DF4D0A8583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8325844"/>
              </p:ext>
            </p:extLst>
          </p:nvPr>
        </p:nvGraphicFramePr>
        <p:xfrm>
          <a:off x="6234683" y="639316"/>
          <a:ext cx="3893906" cy="49466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7" name="Prism 8" r:id="rId5" imgW="2613145" imgH="3319635" progId="Prism8.Document">
                  <p:embed/>
                </p:oleObj>
              </mc:Choice>
              <mc:Fallback>
                <p:oleObj name="Prism 8" r:id="rId5" imgW="2613145" imgH="33196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34683" y="639316"/>
                        <a:ext cx="3893906" cy="49466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BA8383FB-DB60-1518-3A2E-BC8915001E36}"/>
              </a:ext>
            </a:extLst>
          </p:cNvPr>
          <p:cNvSpPr txBox="1"/>
          <p:nvPr/>
        </p:nvSpPr>
        <p:spPr>
          <a:xfrm>
            <a:off x="1385274" y="62915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BCFCCD9-5EC9-3847-33DC-62B98DDC1C8B}"/>
              </a:ext>
            </a:extLst>
          </p:cNvPr>
          <p:cNvSpPr txBox="1"/>
          <p:nvPr/>
        </p:nvSpPr>
        <p:spPr>
          <a:xfrm>
            <a:off x="6026934" y="62915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66978" y="5031456"/>
            <a:ext cx="749808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Supplement figure 2 </a:t>
            </a:r>
          </a:p>
          <a:p>
            <a:r>
              <a:rPr lang="en-US" altLang="zh-CN"/>
              <a:t>A.	Distribution of HER-2 expression in the 36 patients who had IHC tested in our center. </a:t>
            </a:r>
          </a:p>
          <a:p>
            <a:r>
              <a:rPr lang="en-US" altLang="zh-CN"/>
              <a:t>B.	Dynamic changes of CEA from baseline of DV treatment, on-treatment(the point presenting the lowest level after DV treatment), to the point when progression disease occurred.</a:t>
            </a:r>
            <a:endParaRPr lang="en-US" altLang="zh-CN" dirty="0"/>
          </a:p>
        </p:txBody>
      </p:sp>
    </p:spTree>
    <p:extLst>
      <p:ext uri="{BB962C8B-B14F-4D97-AF65-F5344CB8AC3E}">
        <p14:creationId xmlns:p14="http://schemas.microsoft.com/office/powerpoint/2010/main" val="1179390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8</TotalTime>
  <Words>57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rism 8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娟 周</dc:creator>
  <cp:lastModifiedBy>Sheng</cp:lastModifiedBy>
  <cp:revision>53</cp:revision>
  <dcterms:created xsi:type="dcterms:W3CDTF">2024-06-06T07:41:35Z</dcterms:created>
  <dcterms:modified xsi:type="dcterms:W3CDTF">2024-06-22T11:34:25Z</dcterms:modified>
</cp:coreProperties>
</file>